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906000" cy="6858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2" d="100"/>
          <a:sy n="82" d="100"/>
        </p:scale>
        <p:origin x="-1138" y="-77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74293" y="911436"/>
            <a:ext cx="6546850" cy="4251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Rectangle 189"/>
          <p:cNvSpPr>
            <a:spLocks noChangeArrowheads="1"/>
          </p:cNvSpPr>
          <p:nvPr/>
        </p:nvSpPr>
        <p:spPr bwMode="auto">
          <a:xfrm>
            <a:off x="0" y="0"/>
            <a:ext cx="1313996" cy="4531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2000" tIns="72000" rIns="72000" bIns="72000">
            <a:spAutoFit/>
          </a:bodyPr>
          <a:lstStyle/>
          <a:p>
            <a:r>
              <a:rPr lang="en-GB" sz="2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6</a:t>
            </a:r>
            <a:endParaRPr lang="en-GB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62611" y="5393094"/>
            <a:ext cx="8416082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. S6. </a:t>
            </a:r>
            <a:r>
              <a:rPr kumimoji="0" lang="en-GB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wi1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gene expression in the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RNAi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Twi1 transgenic tomato plants after inoculation with Tomato spotted wilt virus (TSWV).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 quantitative reverse transcription-polymerase chain reaction (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qRT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-PCR) analysis of </a:t>
            </a:r>
            <a:r>
              <a:rPr kumimoji="0" lang="en-GB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wi1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gene expression in the leaves from the TSWV-inoculated and Mock-inoculated leaves from the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Moneymaker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nd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RNAi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Twi1 transgenic tomato lines. The control shows </a:t>
            </a:r>
            <a:r>
              <a:rPr kumimoji="0" lang="en-GB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wi1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gene induction before virus inoculation. The </a:t>
            </a:r>
            <a:r>
              <a:rPr kumimoji="0" lang="en-GB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longation Factor 1 alpha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gene was used as an endogenous reference. The results correspond to the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means±SD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of three independent plants from a representative experiment. The experiment was repeated 3 times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104</Words>
  <Application>Microsoft Office PowerPoint</Application>
  <PresentationFormat>A4 (210 x 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UPV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irodrig</dc:creator>
  <cp:lastModifiedBy>irodrig</cp:lastModifiedBy>
  <cp:revision>22</cp:revision>
  <dcterms:created xsi:type="dcterms:W3CDTF">2018-09-12T15:17:25Z</dcterms:created>
  <dcterms:modified xsi:type="dcterms:W3CDTF">2019-09-18T09:18:07Z</dcterms:modified>
</cp:coreProperties>
</file>